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45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2241E2-76B7-4BD6-B6BC-6BA17B8C4A0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0E97C39-4147-464C-B767-D3346793BF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F8A4DE-E48C-4E69-93A5-77185760B3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78246-8565-43F8-B867-FDAAE2B3DD01}" type="datetimeFigureOut">
              <a:rPr lang="en-GB" smtClean="0"/>
              <a:t>15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F968CB-391F-4EA3-8FFB-D40BD65297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DC96FC-02A6-40DE-996F-DE22A5A8D2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3663D-0A06-41FD-A71B-6041919705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32314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31CC7B-9817-4D21-B2FA-B3B1D91BFA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246E47D-B444-4C6C-9782-0E40F75668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CE245A-3E08-446C-AA2C-2A7EE8EC26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78246-8565-43F8-B867-FDAAE2B3DD01}" type="datetimeFigureOut">
              <a:rPr lang="en-GB" smtClean="0"/>
              <a:t>15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25A9DF-5A8E-423D-A18F-42856980CD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A1311F-0D87-452C-B9B1-7DE3636209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3663D-0A06-41FD-A71B-6041919705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70585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571F8E2-0CE9-4836-90D1-0DD75787EDA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DD584E-7814-49A4-B58E-59EE5DD8F0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9D9616-E216-41AC-AC69-A3CBE1B7E0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78246-8565-43F8-B867-FDAAE2B3DD01}" type="datetimeFigureOut">
              <a:rPr lang="en-GB" smtClean="0"/>
              <a:t>15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1E6385-6BBE-4AA3-BDC8-66D8757A3A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449E65-2267-4BAF-8E76-BA9DB8A376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3663D-0A06-41FD-A71B-6041919705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40196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09A7C5-97FC-4353-B14B-F314FBE53D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524A8B-0BA1-4A9F-BEE4-CF0F4070900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BFA13D-F866-465A-AEFE-02CF76D889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78246-8565-43F8-B867-FDAAE2B3DD01}" type="datetimeFigureOut">
              <a:rPr lang="en-GB" smtClean="0"/>
              <a:t>15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F2CF92-EECD-46EC-8AF4-66AAA6E66D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E5B7E5-432A-477A-8C7D-81DFAD7D7D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3663D-0A06-41FD-A71B-6041919705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48870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EF4C2B-ECBF-4827-A3F8-07DA0E3093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E33850-AD46-47CB-90E4-525E7742C0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1B23F1-3D89-4533-A51A-986D7B0F88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78246-8565-43F8-B867-FDAAE2B3DD01}" type="datetimeFigureOut">
              <a:rPr lang="en-GB" smtClean="0"/>
              <a:t>15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91C0E2-2E54-4321-B46E-E20119066D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242C6A-358A-4DEB-9A0B-20727F93EE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3663D-0A06-41FD-A71B-6041919705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38222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776FCB-15BF-400C-8ACA-F9E35D4AD5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F24529A-7B5B-47E4-A198-81CE3A8972E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6BFF0A-315D-4000-8556-BCB123268E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EDB0EF-3E14-4D4F-BAFD-DCBA2AFE0E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78246-8565-43F8-B867-FDAAE2B3DD01}" type="datetimeFigureOut">
              <a:rPr lang="en-GB" smtClean="0"/>
              <a:t>15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8808E6-ACAD-49E0-A466-75F3A760B6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28B7996-F6F0-4EA3-AC65-858B39A16A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3663D-0A06-41FD-A71B-6041919705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41673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0A7F32-4B77-4B45-AF9B-E07D6B353F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ECFF3FE-9A28-4ADF-95FF-8A3B6A5D08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62FFC2-95E8-4003-9902-324D0D534F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7EAD9B9-FDA7-4CEA-9E0B-5297BFFD77F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D1C9D7E-53B5-45BA-BFC2-336D9E485F2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49268EC-B31D-4075-ABFD-58B87A8CD8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78246-8565-43F8-B867-FDAAE2B3DD01}" type="datetimeFigureOut">
              <a:rPr lang="en-GB" smtClean="0"/>
              <a:t>15/02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A53E210-3ACC-47EB-864D-B1C66B99FF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8CF4664-B942-4FC4-9BB8-923D0349E3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3663D-0A06-41FD-A71B-6041919705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41328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913239-ABFC-4C0C-9092-9C2A088C74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294B3B4-DF56-4AFC-8479-F7A4158C0B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78246-8565-43F8-B867-FDAAE2B3DD01}" type="datetimeFigureOut">
              <a:rPr lang="en-GB" smtClean="0"/>
              <a:t>15/02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6CD5D0B-9B65-4DB5-A019-E82344E286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B261E74-2BCA-4C1C-8EA7-A6AAEE33B8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3663D-0A06-41FD-A71B-6041919705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97428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14FF903-5D0A-49E5-B9B6-6801E67D15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78246-8565-43F8-B867-FDAAE2B3DD01}" type="datetimeFigureOut">
              <a:rPr lang="en-GB" smtClean="0"/>
              <a:t>15/02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A6F6201-1B9E-4E1D-8FF0-DEFCCEB8B3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CE5222A-3C34-4DA6-BBF3-101C08A755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3663D-0A06-41FD-A71B-6041919705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18584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EFE97D-23B8-4C1F-940D-6625806E04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75C3A5-319B-426B-97E4-4C78B55D44E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A4D26F-633F-4156-995E-9883A31707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2AB46DA-E1FA-44F1-927A-F1D8E55F0A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78246-8565-43F8-B867-FDAAE2B3DD01}" type="datetimeFigureOut">
              <a:rPr lang="en-GB" smtClean="0"/>
              <a:t>15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AA0D322-4B99-4B12-A092-983E2E428A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9A85A9-B16C-48B8-9A01-EC420974A6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3663D-0A06-41FD-A71B-6041919705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48507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C76195-67B2-46AA-84CC-1ADF235246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336A9D4-45CF-4E7C-AE4D-BD0D2476DA3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C8DC5C2-D99F-490A-995D-0FC347B7EA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8EF5EB6-CD01-4457-B2A3-B3BF81D53E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78246-8565-43F8-B867-FDAAE2B3DD01}" type="datetimeFigureOut">
              <a:rPr lang="en-GB" smtClean="0"/>
              <a:t>15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C972F0-AA3D-4DC3-94E1-D5183AEB4D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A88B713-38FC-4C68-B77F-A87C7F9248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3663D-0A06-41FD-A71B-6041919705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08149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EBA4081-66EB-40CF-8F7C-54E9D8CA5A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D82922-FE8D-49BA-BD82-83D31C9E1F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8EB882-51BA-4D2E-A51A-F5FA8CD88B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B78246-8565-43F8-B867-FDAAE2B3DD01}" type="datetimeFigureOut">
              <a:rPr lang="en-GB" smtClean="0"/>
              <a:t>15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CDE527-4A26-4B00-839A-DAA87FA8B13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1047D2-EFBA-4ADF-A7A1-08CFEB4FB99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C3663D-0A06-41FD-A71B-6041919705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48405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https://www.dropbox.com/s/22tks0hhp31qokq/Flight%20test%20device%20instructional%20video%20cut2%20with%20sub%20and%20music.mp4?dl=0" TargetMode="Externa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0BF8CB-E47A-4AE2-AA2F-EF605CF98383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GB" dirty="0"/>
              <a:t>Supplementary material S14. Video of the Flight test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03D2E34D-A299-470E-93A3-82AD174A68F8}"/>
              </a:ext>
            </a:extLst>
          </p:cNvPr>
          <p:cNvSpPr/>
          <p:nvPr/>
        </p:nvSpPr>
        <p:spPr>
          <a:xfrm>
            <a:off x="3378200" y="4347402"/>
            <a:ext cx="6096000" cy="923330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GB" u="sng" dirty="0">
                <a:solidFill>
                  <a:srgbClr val="0000FF"/>
                </a:solidFill>
                <a:latin typeface="Helvetica Neue"/>
                <a:hlinkClick r:id="rId2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www.dropbox.com/s/22tks0hhp31qokq/Flight%20test%20device%20instructional%20video%20cut2%20with%20sub%20and%20music.mp4?dl=0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976962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4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 Neue</vt:lpstr>
      <vt:lpstr>Office Theme</vt:lpstr>
      <vt:lpstr>Supplementary material S14. Video of the Flight tes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IGA H</dc:creator>
  <cp:lastModifiedBy>MAIGA H</cp:lastModifiedBy>
  <cp:revision>2</cp:revision>
  <dcterms:created xsi:type="dcterms:W3CDTF">2022-02-14T23:03:55Z</dcterms:created>
  <dcterms:modified xsi:type="dcterms:W3CDTF">2022-02-14T23:10:19Z</dcterms:modified>
</cp:coreProperties>
</file>